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57DA5CDA-B669-79AC-C6A1-02C8F19407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584066"/>
            <a:ext cx="9144000" cy="751904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2 Forest plot of the relationship between feeding initiation within 48h of ICU admission and refeeding syndrome in acutely ill patient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EBC9F23B-82B2-9A87-1488-AAD47051C49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133600" y="1181878"/>
            <a:ext cx="7924800" cy="2074085"/>
            <a:chOff x="1344" y="989"/>
            <a:chExt cx="4992" cy="1062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E625A1B0-54A7-3003-BC16-EF87A7F6BD7B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344" y="989"/>
              <a:ext cx="4992" cy="1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A0BDDDF5-4DB1-5C6F-8D49-D63A4A9C80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" y="989"/>
              <a:ext cx="4992" cy="1062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4613EDAD-F1DC-9E00-DFC6-BB90896E48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4" y="1182"/>
              <a:ext cx="499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A14E7AD1-D7DD-711E-C924-C3613A1AA4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" y="1109"/>
              <a:ext cx="76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CB7D85E7-46CF-E1EC-3853-2E84E15529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" y="1216"/>
              <a:ext cx="38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en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394AA886-3B65-7640-5BCE-C6FD1BD5BC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" y="1314"/>
              <a:ext cx="320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ui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3BABE811-6566-8303-AE57-F41BAE5BFA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" y="1409"/>
              <a:ext cx="4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5518B0CC-A31C-41E8-6D0E-D56C4D89E7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" y="1592"/>
              <a:ext cx="5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09F10F39-CCB7-8E5B-05CF-1F350BD8C0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" y="1699"/>
              <a:ext cx="42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otal even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B90E03F2-8438-06CB-4C40-77CEFCAFE7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" y="1795"/>
              <a:ext cx="187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Chi² = 0.48, df = 2 (P = 0.79); I² = 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DA69506A-72C7-1BDB-F6F9-8809BC40AE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" y="1892"/>
              <a:ext cx="147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5.57 (P &lt; 0.0000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88E97F8D-5F77-B4F1-FF78-A1A25EE421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9" y="1109"/>
              <a:ext cx="298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Even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074B9D8F-6C1E-E1B1-DF9F-2484447066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7" y="1216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E70A234F-117B-8176-ABF2-B1CECD2E22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7" y="1314"/>
              <a:ext cx="11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85A2EFAE-83ED-747F-9011-AF6E15AB16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7" y="1409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8E055FF3-DCE2-C5E4-3A73-C07E12116E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7" y="1699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F0E7A5DB-08B1-3957-F2A2-2138A9B5CA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9" y="1109"/>
              <a:ext cx="23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F52A81CF-3FA6-9D20-B5CC-C82EE2233D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7" y="1216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B61762F1-3587-3AFC-AB07-A4A6A10A55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7" y="1314"/>
              <a:ext cx="11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740DDD93-52AB-EAC8-3537-BC9993A00E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7" y="1409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06AF378C-32CB-2F44-240E-B1DAE17BE5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" y="1592"/>
              <a:ext cx="15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2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88BB633A-DC67-9F56-F642-47228912F3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8" y="1109"/>
              <a:ext cx="298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Even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79B5B9C5-C6F1-E6C1-13CF-4846DA45F9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1216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388C62F6-64DD-C20A-FF12-9EB854D357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1314"/>
              <a:ext cx="11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28893BEA-71A2-DA88-F0CB-DB7A423E54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1409"/>
              <a:ext cx="12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09CFD581-A004-23AA-39ED-2E28E915AF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1699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7A18E54C-E6A8-484B-AE27-65B993A463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6" y="1109"/>
              <a:ext cx="22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87CA7188-4B2B-2DBF-AC60-26B6084782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4" y="1216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BD6ED955-53B0-628F-59A7-C8CB5CE2C8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4" y="1314"/>
              <a:ext cx="1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04EA6558-43D0-01D6-D1B9-5085EF6CDB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4" y="1409"/>
              <a:ext cx="16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04D41431-29AC-4BBA-5335-C18F06D6CC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8" y="1592"/>
              <a:ext cx="15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28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7E6DFDBD-374B-5F43-865B-A5CD582B2F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4" y="1109"/>
              <a:ext cx="305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0DDEE99B-2B4D-F1A2-A69E-3880A30637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0" y="1216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2.6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D658886B-30EA-A452-F0FA-1BDFC1C8CB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0" y="1314"/>
              <a:ext cx="236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3.7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765A4318-8F52-1163-598D-E35BBFAC72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0" y="1409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3.7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96DAC1F1-FC6C-D4A6-8F5A-CC29D8B20E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4" y="1592"/>
              <a:ext cx="27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7C0B4CD8-A1A1-3893-5321-F568F54142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5" y="1109"/>
              <a:ext cx="74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-H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426CBBA6-FEC9-4AF3-DDE9-09E2AEB4D3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1" y="1216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14 [1.30, 3.51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D668F1C0-5D0A-B71E-31F0-582F187A86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1" y="1314"/>
              <a:ext cx="55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11 [1.40, 3.19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07CF9D76-7243-8D03-728A-41BCB01242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1" y="1409"/>
              <a:ext cx="60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79 [1.24, 2.58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ED6B0EEB-7020-D66C-D68E-F83A80B354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7" y="1592"/>
              <a:ext cx="562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.98 [1.56, 2.51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1F22A01D-BEAE-B9BC-C780-62EA527BFA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3" y="1013"/>
              <a:ext cx="403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2C0C9F72-8323-5101-1D11-D90310C855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" y="1013"/>
              <a:ext cx="558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56786EDF-EAC6-6858-612B-36EDEFE3B7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2" y="1013"/>
              <a:ext cx="387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isk Rati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5C084544-6572-B483-C36A-2F92BD1D0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32" y="1013"/>
              <a:ext cx="386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isk Rati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3A75348D-CAB7-0AB9-9178-1D04DB5A73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99" y="1109"/>
              <a:ext cx="745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-H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Line 50">
              <a:extLst>
                <a:ext uri="{FF2B5EF4-FFF2-40B4-BE49-F238E27FC236}">
                  <a16:creationId xmlns:a16="http://schemas.microsoft.com/office/drawing/2014/main" id="{AC9AAC30-D1D7-E792-379D-09CE7FB129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06" y="1182"/>
              <a:ext cx="0" cy="628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Line 51">
              <a:extLst>
                <a:ext uri="{FF2B5EF4-FFF2-40B4-BE49-F238E27FC236}">
                  <a16:creationId xmlns:a16="http://schemas.microsoft.com/office/drawing/2014/main" id="{C7981F7F-7EB6-C973-91EB-71CB5182CB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61" y="1230"/>
              <a:ext cx="207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39169E6B-6E44-6CD8-D2BC-24CE79649F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8" y="1219"/>
              <a:ext cx="34" cy="34"/>
            </a:xfrm>
            <a:prstGeom prst="rect">
              <a:avLst/>
            </a:prstGeom>
            <a:solidFill>
              <a:srgbClr val="0000C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6" name="Line 53">
              <a:extLst>
                <a:ext uri="{FF2B5EF4-FFF2-40B4-BE49-F238E27FC236}">
                  <a16:creationId xmlns:a16="http://schemas.microsoft.com/office/drawing/2014/main" id="{B8CE2ECC-EC53-E1BE-7B04-CEB2F86F52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5" y="1327"/>
              <a:ext cx="17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A9E4DB79-0666-C360-8712-DC4AA03481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0" y="1311"/>
              <a:ext cx="44" cy="44"/>
            </a:xfrm>
            <a:prstGeom prst="rect">
              <a:avLst/>
            </a:prstGeom>
            <a:solidFill>
              <a:srgbClr val="0000C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" name="Line 55">
              <a:extLst>
                <a:ext uri="{FF2B5EF4-FFF2-40B4-BE49-F238E27FC236}">
                  <a16:creationId xmlns:a16="http://schemas.microsoft.com/office/drawing/2014/main" id="{49ED2900-29C7-F461-618C-AD170B76A0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51" y="1423"/>
              <a:ext cx="153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67177502-1D7E-0CC6-BA18-B0D849035B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0" y="1402"/>
              <a:ext cx="54" cy="54"/>
            </a:xfrm>
            <a:prstGeom prst="rect">
              <a:avLst/>
            </a:prstGeom>
            <a:solidFill>
              <a:srgbClr val="0000C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0" name="Freeform 57">
              <a:extLst>
                <a:ext uri="{FF2B5EF4-FFF2-40B4-BE49-F238E27FC236}">
                  <a16:creationId xmlns:a16="http://schemas.microsoft.com/office/drawing/2014/main" id="{46651456-D2DB-E202-6A37-9C6A1198DFE1}"/>
                </a:ext>
              </a:extLst>
            </p:cNvPr>
            <p:cNvSpPr>
              <a:spLocks/>
            </p:cNvSpPr>
            <p:nvPr/>
          </p:nvSpPr>
          <p:spPr bwMode="auto">
            <a:xfrm>
              <a:off x="5393" y="1574"/>
              <a:ext cx="102" cy="85"/>
            </a:xfrm>
            <a:custGeom>
              <a:avLst/>
              <a:gdLst>
                <a:gd name="T0" fmla="*/ 180 w 340"/>
                <a:gd name="T1" fmla="*/ 280 h 280"/>
                <a:gd name="T2" fmla="*/ 0 w 340"/>
                <a:gd name="T3" fmla="*/ 140 h 280"/>
                <a:gd name="T4" fmla="*/ 180 w 340"/>
                <a:gd name="T5" fmla="*/ 0 h 280"/>
                <a:gd name="T6" fmla="*/ 340 w 340"/>
                <a:gd name="T7" fmla="*/ 140 h 280"/>
                <a:gd name="T8" fmla="*/ 180 w 34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40" h="280">
                  <a:moveTo>
                    <a:pt x="180" y="280"/>
                  </a:moveTo>
                  <a:lnTo>
                    <a:pt x="0" y="140"/>
                  </a:lnTo>
                  <a:lnTo>
                    <a:pt x="180" y="0"/>
                  </a:lnTo>
                  <a:lnTo>
                    <a:pt x="340" y="140"/>
                  </a:lnTo>
                  <a:lnTo>
                    <a:pt x="18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" name="Line 58">
              <a:extLst>
                <a:ext uri="{FF2B5EF4-FFF2-40B4-BE49-F238E27FC236}">
                  <a16:creationId xmlns:a16="http://schemas.microsoft.com/office/drawing/2014/main" id="{81BDAA90-4A2E-6F37-3A6F-C271FED6CB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42" y="1810"/>
              <a:ext cx="192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" name="Line 59">
              <a:extLst>
                <a:ext uri="{FF2B5EF4-FFF2-40B4-BE49-F238E27FC236}">
                  <a16:creationId xmlns:a16="http://schemas.microsoft.com/office/drawing/2014/main" id="{D0173B9B-DFE9-5F85-96EA-90DD189AD2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42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8C468E9E-FAF4-520B-EB11-C6E1F9B999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2" y="1845"/>
              <a:ext cx="17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Line 61">
              <a:extLst>
                <a:ext uri="{FF2B5EF4-FFF2-40B4-BE49-F238E27FC236}">
                  <a16:creationId xmlns:a16="http://schemas.microsoft.com/office/drawing/2014/main" id="{C65A9974-83AC-6384-43FF-2744835054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24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92D3CDC0-3479-56DC-81D4-BD07B9909A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4" y="1845"/>
              <a:ext cx="13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Line 63">
              <a:extLst>
                <a:ext uri="{FF2B5EF4-FFF2-40B4-BE49-F238E27FC236}">
                  <a16:creationId xmlns:a16="http://schemas.microsoft.com/office/drawing/2014/main" id="{2F887A25-9AD7-78CF-862D-4BEAC32D35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06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DEB6843B-9F95-5F04-9AE2-D29B84BDEB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6" y="1845"/>
              <a:ext cx="7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Line 65">
              <a:extLst>
                <a:ext uri="{FF2B5EF4-FFF2-40B4-BE49-F238E27FC236}">
                  <a16:creationId xmlns:a16="http://schemas.microsoft.com/office/drawing/2014/main" id="{0315BE08-86A3-7098-EB55-9696BB2DE8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88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FE7247F8-793A-2FE6-6E38-FCDE0536D7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8" y="1845"/>
              <a:ext cx="11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Line 67">
              <a:extLst>
                <a:ext uri="{FF2B5EF4-FFF2-40B4-BE49-F238E27FC236}">
                  <a16:creationId xmlns:a16="http://schemas.microsoft.com/office/drawing/2014/main" id="{41317456-3580-9353-2EAB-CB69E6CE13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70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58B65677-180A-DE1F-A840-69EC309B1F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0" y="1845"/>
              <a:ext cx="1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A2C3D6DE-592C-86EC-54FB-E2861560F1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3" y="1932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F4667DA8-BE2D-DCE2-DB73-87BF006A89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36" y="1932"/>
              <a:ext cx="84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4623105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6</Words>
  <Application>Microsoft Office PowerPoint</Application>
  <PresentationFormat>宽屏</PresentationFormat>
  <Paragraphs>5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5</cp:revision>
  <dcterms:created xsi:type="dcterms:W3CDTF">2023-08-09T12:44:00Z</dcterms:created>
  <dcterms:modified xsi:type="dcterms:W3CDTF">2026-02-06T16:05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